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32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154"/>
    <p:restoredTop sz="94595"/>
  </p:normalViewPr>
  <p:slideViewPr>
    <p:cSldViewPr snapToGrid="0" snapToObjects="1">
      <p:cViewPr varScale="1">
        <p:scale>
          <a:sx n="96" d="100"/>
          <a:sy n="96" d="100"/>
        </p:scale>
        <p:origin x="174" y="5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ters, Christopher" userId="62418469-15cb-4bfd-8077-e64d9edbe607" providerId="ADAL" clId="{C0E79CA1-A2D9-4EB1-8EDC-6DC1EFC82B88}"/>
    <pc:docChg chg="delSld">
      <pc:chgData name="Waters, Christopher" userId="62418469-15cb-4bfd-8077-e64d9edbe607" providerId="ADAL" clId="{C0E79CA1-A2D9-4EB1-8EDC-6DC1EFC82B88}" dt="2020-10-06T14:54:29.606" v="8" actId="47"/>
      <pc:docMkLst>
        <pc:docMk/>
      </pc:docMkLst>
      <pc:sldChg chg="del">
        <pc:chgData name="Waters, Christopher" userId="62418469-15cb-4bfd-8077-e64d9edbe607" providerId="ADAL" clId="{C0E79CA1-A2D9-4EB1-8EDC-6DC1EFC82B88}" dt="2020-10-06T14:54:26.397" v="3" actId="47"/>
        <pc:sldMkLst>
          <pc:docMk/>
          <pc:sldMk cId="2774148630" sldId="261"/>
        </pc:sldMkLst>
      </pc:sldChg>
      <pc:sldChg chg="del">
        <pc:chgData name="Waters, Christopher" userId="62418469-15cb-4bfd-8077-e64d9edbe607" providerId="ADAL" clId="{C0E79CA1-A2D9-4EB1-8EDC-6DC1EFC82B88}" dt="2020-10-06T14:54:29.606" v="8" actId="47"/>
        <pc:sldMkLst>
          <pc:docMk/>
          <pc:sldMk cId="1851293959" sldId="262"/>
        </pc:sldMkLst>
      </pc:sldChg>
      <pc:sldChg chg="del">
        <pc:chgData name="Waters, Christopher" userId="62418469-15cb-4bfd-8077-e64d9edbe607" providerId="ADAL" clId="{C0E79CA1-A2D9-4EB1-8EDC-6DC1EFC82B88}" dt="2020-10-06T14:54:27.697" v="5" actId="47"/>
        <pc:sldMkLst>
          <pc:docMk/>
          <pc:sldMk cId="2721653835" sldId="268"/>
        </pc:sldMkLst>
      </pc:sldChg>
      <pc:sldChg chg="del">
        <pc:chgData name="Waters, Christopher" userId="62418469-15cb-4bfd-8077-e64d9edbe607" providerId="ADAL" clId="{C0E79CA1-A2D9-4EB1-8EDC-6DC1EFC82B88}" dt="2020-10-06T14:54:26.753" v="4" actId="47"/>
        <pc:sldMkLst>
          <pc:docMk/>
          <pc:sldMk cId="1523904752" sldId="271"/>
        </pc:sldMkLst>
      </pc:sldChg>
      <pc:sldChg chg="del">
        <pc:chgData name="Waters, Christopher" userId="62418469-15cb-4bfd-8077-e64d9edbe607" providerId="ADAL" clId="{C0E79CA1-A2D9-4EB1-8EDC-6DC1EFC82B88}" dt="2020-10-06T14:54:25.252" v="0" actId="47"/>
        <pc:sldMkLst>
          <pc:docMk/>
          <pc:sldMk cId="4023863908" sldId="274"/>
        </pc:sldMkLst>
      </pc:sldChg>
      <pc:sldChg chg="del">
        <pc:chgData name="Waters, Christopher" userId="62418469-15cb-4bfd-8077-e64d9edbe607" providerId="ADAL" clId="{C0E79CA1-A2D9-4EB1-8EDC-6DC1EFC82B88}" dt="2020-10-06T14:54:26.075" v="2" actId="47"/>
        <pc:sldMkLst>
          <pc:docMk/>
          <pc:sldMk cId="2661597603" sldId="278"/>
        </pc:sldMkLst>
      </pc:sldChg>
      <pc:sldChg chg="del">
        <pc:chgData name="Waters, Christopher" userId="62418469-15cb-4bfd-8077-e64d9edbe607" providerId="ADAL" clId="{C0E79CA1-A2D9-4EB1-8EDC-6DC1EFC82B88}" dt="2020-10-06T14:54:28.753" v="7" actId="47"/>
        <pc:sldMkLst>
          <pc:docMk/>
          <pc:sldMk cId="3940385423" sldId="314"/>
        </pc:sldMkLst>
      </pc:sldChg>
      <pc:sldChg chg="del">
        <pc:chgData name="Waters, Christopher" userId="62418469-15cb-4bfd-8077-e64d9edbe607" providerId="ADAL" clId="{C0E79CA1-A2D9-4EB1-8EDC-6DC1EFC82B88}" dt="2020-10-06T14:54:28.281" v="6" actId="47"/>
        <pc:sldMkLst>
          <pc:docMk/>
          <pc:sldMk cId="200701545" sldId="316"/>
        </pc:sldMkLst>
      </pc:sldChg>
      <pc:sldChg chg="del">
        <pc:chgData name="Waters, Christopher" userId="62418469-15cb-4bfd-8077-e64d9edbe607" providerId="ADAL" clId="{C0E79CA1-A2D9-4EB1-8EDC-6DC1EFC82B88}" dt="2020-10-06T14:54:25.717" v="1" actId="47"/>
        <pc:sldMkLst>
          <pc:docMk/>
          <pc:sldMk cId="1186078525" sldId="322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659830-ED58-824D-9109-DC876CA9D45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37C91B-74FD-C346-BDAE-87F7850D56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00C38A-A642-F24A-99D9-AB5701CE3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B19F02-A694-3F47-BB15-90635F330F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956B6D-7046-7847-8768-70E51ADFDD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135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B6F415-AA81-EE46-9570-2B07B39509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0B9750-321C-1241-B7D3-7E7D4885C4F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6538BE-95B7-874F-B826-FA8982FE3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B05F8-2C54-5445-94E2-5CC7054D8C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7B0826-2E1F-AA47-BF02-CC169E0004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063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076CCE1-B819-2447-894E-F5E7D505691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4924AF-7A68-CC42-AF62-91A3FFFA27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05309F-C7FF-E141-8907-2A9E876DF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93C382-ABB6-3E41-BF15-60DD77554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DC47CF-5664-964E-B7AE-5DF772472F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3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D328FD-B344-6D45-9E6B-58D8F0098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F21223-223A-4947-AEE8-EFB59A3946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5EC0A4-4A62-6045-BF7A-87D56A2100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A07320-0E8C-C845-BE63-799A9C6CD1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574C76-B280-D940-8A81-F24BFE2D71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3173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E7B8C8-4381-4E4D-B2A5-3E40C187D0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A1A0C9-84BE-B14C-A2A6-4E29AD2354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10993C-8B45-C94E-9886-304BCA387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2B82EB-2E72-0F4E-8CCB-A4AE3C0C6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35B4D5-4317-4B41-B4E6-90BDBBBF98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25408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8E438D-A2B7-364F-A82D-9551F435A1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CBC450-5751-0E45-8BD5-87C9594C4E6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274DAD-F8D3-8744-B5A2-FAA227CDCD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2C7D8D-75AE-A64A-BC82-10D1AA3EE0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4DABFC-F9F3-0242-8984-4D3130C3EE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3A1453-0DBF-774F-86A7-2F3C83B1B6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36146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8C7AC8-2C6D-364A-844D-8CC38E1CD8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9D3A33-5920-F941-9974-2684729885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48F2CE7-C798-584B-B9DE-67235E7A04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C9450E5-ADF8-8642-9F0B-CC2C679932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BE74728-10D0-2244-AC13-B23325FC7B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D44FA7-207E-1C48-B266-54289530C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C14F2B4-08FB-8D4B-A2BA-820D0E3BDE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7A996D7-7DEE-B749-B1AE-FC8A1CE887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010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D0B843-10A2-E549-8B49-88BAF81F45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64447E-DA97-AF44-938B-80CC64AD9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30D34F2-1F36-2449-9BA0-4950F7F89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0F43699-E8BB-F742-A9E6-11704511E1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581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930F095-D827-0F40-AC34-B8EBC69991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A9818E-C21D-3E49-8794-24615DD7D3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2723274-E0F0-8044-A30E-37489EB32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11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37ED2B-B588-F542-B327-FF6FA888EB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87E501-EB11-2843-A2D5-90DF257448C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C3D69D2-26CB-974C-A837-5CEE017D36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F43738-4D89-DD47-B523-8FDA04C2C4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9C1A8E-27EB-4741-B9AF-10FBBA5578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BD9C3A-C2D7-424F-9ABA-5AFFC01DE2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599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E104C6-6CCA-A740-80C7-57714D2505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5ACE8D9-E09C-7449-9C65-A2E5D4AA72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B5B7302-2E67-A949-85C1-CFCD609997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AC8B09-E20E-764B-8159-D4C03580D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B9739A-3F6F-E84C-A4A7-6876E2456E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B7B9D2-AAE2-5840-B433-F7F35B2C8F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260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54170AA-1612-BD45-9A0A-015965E9D3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FB8510-C26C-B84A-8B06-5D242E0E84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ABD935-A200-2D44-958B-DC444F57FE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777A84-49DE-5F47-9A53-90A214EFC125}" type="datetimeFigureOut">
              <a:rPr lang="en-US" smtClean="0"/>
              <a:t>10/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906807-A097-6A4D-A8D9-CFE1236614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1A3A0E-EA09-FE4B-8A12-89ABAFD045F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ACC35D-3EF6-AE49-9F2C-B6ADEDF5C9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41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91B307D-397B-E544-9985-ABEC99F449BF}"/>
              </a:ext>
            </a:extLst>
          </p:cNvPr>
          <p:cNvSpPr txBox="1"/>
          <p:nvPr/>
        </p:nvSpPr>
        <p:spPr>
          <a:xfrm>
            <a:off x="7509" y="-30012"/>
            <a:ext cx="118189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reatment regimens used for the selection of resistant mutants. 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D3A79014-AC85-504A-BD3D-2F3FB77DA6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972078"/>
              </p:ext>
            </p:extLst>
          </p:nvPr>
        </p:nvGraphicFramePr>
        <p:xfrm>
          <a:off x="64833" y="244759"/>
          <a:ext cx="5747224" cy="493776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436806">
                  <a:extLst>
                    <a:ext uri="{9D8B030D-6E8A-4147-A177-3AD203B41FA5}">
                      <a16:colId xmlns:a16="http://schemas.microsoft.com/office/drawing/2014/main" val="2323871151"/>
                    </a:ext>
                  </a:extLst>
                </a:gridCol>
                <a:gridCol w="1436806">
                  <a:extLst>
                    <a:ext uri="{9D8B030D-6E8A-4147-A177-3AD203B41FA5}">
                      <a16:colId xmlns:a16="http://schemas.microsoft.com/office/drawing/2014/main" val="2131376368"/>
                    </a:ext>
                  </a:extLst>
                </a:gridCol>
                <a:gridCol w="1436806">
                  <a:extLst>
                    <a:ext uri="{9D8B030D-6E8A-4147-A177-3AD203B41FA5}">
                      <a16:colId xmlns:a16="http://schemas.microsoft.com/office/drawing/2014/main" val="4281271109"/>
                    </a:ext>
                  </a:extLst>
                </a:gridCol>
                <a:gridCol w="1436806">
                  <a:extLst>
                    <a:ext uri="{9D8B030D-6E8A-4147-A177-3AD203B41FA5}">
                      <a16:colId xmlns:a16="http://schemas.microsoft.com/office/drawing/2014/main" val="2056706485"/>
                    </a:ext>
                  </a:extLst>
                </a:gridCol>
              </a:tblGrid>
              <a:tr h="211298">
                <a:tc>
                  <a:txBody>
                    <a:bodyPr/>
                    <a:lstStyle/>
                    <a:p>
                      <a:pPr marR="0" algn="ctr" fontAlgn="b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bramyc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closan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Part A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6330027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marR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9707860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marR="0"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47475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475615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dual Start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0112720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67822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82230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3927406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688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8890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2085127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8412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841287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2802030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97732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7732674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768664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82475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247524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0484020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03536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35360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8889282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76480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6480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1765754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2354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2354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Moderate Start </a:t>
                      </a: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5692772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1764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.764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631118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80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80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12366788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0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0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7987522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.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7984142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4749897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34241785"/>
                  </a:ext>
                </a:extLst>
              </a:tr>
              <a:tr h="21129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Tob</a:t>
                      </a:r>
                      <a:r>
                        <a:rPr lang="en-US" sz="12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mycin MIC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33134198"/>
                  </a:ext>
                </a:extLst>
              </a:tr>
            </a:tbl>
          </a:graphicData>
        </a:graphic>
      </p:graphicFrame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41F9137E-53AA-484A-842A-0D766B3ADA9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4324106"/>
              </p:ext>
            </p:extLst>
          </p:nvPr>
        </p:nvGraphicFramePr>
        <p:xfrm>
          <a:off x="5910370" y="256858"/>
          <a:ext cx="6204040" cy="41148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551010">
                  <a:extLst>
                    <a:ext uri="{9D8B030D-6E8A-4147-A177-3AD203B41FA5}">
                      <a16:colId xmlns:a16="http://schemas.microsoft.com/office/drawing/2014/main" val="2898769266"/>
                    </a:ext>
                  </a:extLst>
                </a:gridCol>
                <a:gridCol w="1551010">
                  <a:extLst>
                    <a:ext uri="{9D8B030D-6E8A-4147-A177-3AD203B41FA5}">
                      <a16:colId xmlns:a16="http://schemas.microsoft.com/office/drawing/2014/main" val="1207161767"/>
                    </a:ext>
                  </a:extLst>
                </a:gridCol>
                <a:gridCol w="1551010">
                  <a:extLst>
                    <a:ext uri="{9D8B030D-6E8A-4147-A177-3AD203B41FA5}">
                      <a16:colId xmlns:a16="http://schemas.microsoft.com/office/drawing/2014/main" val="3971295173"/>
                    </a:ext>
                  </a:extLst>
                </a:gridCol>
                <a:gridCol w="1551010">
                  <a:extLst>
                    <a:ext uri="{9D8B030D-6E8A-4147-A177-3AD203B41FA5}">
                      <a16:colId xmlns:a16="http://schemas.microsoft.com/office/drawing/2014/main" val="2193632130"/>
                    </a:ext>
                  </a:extLst>
                </a:gridCol>
              </a:tblGrid>
              <a:tr h="271797">
                <a:tc>
                  <a:txBody>
                    <a:bodyPr/>
                    <a:lstStyle/>
                    <a:p>
                      <a:pPr marR="0" algn="ctr" fontAlgn="b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bramyc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iclosan 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Part B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8631821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dual &amp; Moderate</a:t>
                      </a:r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360976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.7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0.5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07338892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.3072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2.30148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4310504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824409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5.25320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089862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592770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9.57652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1444110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.958968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5.41667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4924302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.3656024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2.93430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44061849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.377874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.307045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0385000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.7175454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3.73136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1858730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3063055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7.42451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2528150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.32115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3.62676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7920949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7.26511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2.603843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6224466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8.057547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4.64959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5720" marR="4572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3354371"/>
                  </a:ext>
                </a:extLst>
              </a:tr>
              <a:tr h="27179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0.14948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0.088981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23405982"/>
                  </a:ext>
                </a:extLst>
              </a:tr>
            </a:tbl>
          </a:graphicData>
        </a:graphic>
      </p:graphicFrame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727376E9-C1EC-484B-9E2F-DF8B5674906B}"/>
              </a:ext>
            </a:extLst>
          </p:cNvPr>
          <p:cNvCxnSpPr>
            <a:cxnSpLocks/>
          </p:cNvCxnSpPr>
          <p:nvPr/>
        </p:nvCxnSpPr>
        <p:spPr>
          <a:xfrm>
            <a:off x="4550421" y="1094621"/>
            <a:ext cx="0" cy="4009292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DA42E5A6-96CD-6F47-B401-98331F5B9967}"/>
              </a:ext>
            </a:extLst>
          </p:cNvPr>
          <p:cNvCxnSpPr>
            <a:cxnSpLocks/>
          </p:cNvCxnSpPr>
          <p:nvPr/>
        </p:nvCxnSpPr>
        <p:spPr>
          <a:xfrm>
            <a:off x="5054515" y="3343107"/>
            <a:ext cx="0" cy="1760806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2FA43087-5A06-C248-B79C-41BC01FD5E37}"/>
              </a:ext>
            </a:extLst>
          </p:cNvPr>
          <p:cNvCxnSpPr>
            <a:cxnSpLocks/>
          </p:cNvCxnSpPr>
          <p:nvPr/>
        </p:nvCxnSpPr>
        <p:spPr>
          <a:xfrm>
            <a:off x="10906670" y="869538"/>
            <a:ext cx="0" cy="3123027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1A52E44A-DABC-A84F-88DB-33504F37E597}"/>
              </a:ext>
            </a:extLst>
          </p:cNvPr>
          <p:cNvCxnSpPr>
            <a:cxnSpLocks/>
          </p:cNvCxnSpPr>
          <p:nvPr/>
        </p:nvCxnSpPr>
        <p:spPr>
          <a:xfrm>
            <a:off x="11565509" y="869538"/>
            <a:ext cx="0" cy="3123027"/>
          </a:xfrm>
          <a:prstGeom prst="straightConnector1">
            <a:avLst/>
          </a:prstGeom>
          <a:ln w="127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6971343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4DAA46E096FC440AE51667620FC2471" ma:contentTypeVersion="8" ma:contentTypeDescription="Create a new document." ma:contentTypeScope="" ma:versionID="8184695aebda49fdb4c591f5f069ddef">
  <xsd:schema xmlns:xsd="http://www.w3.org/2001/XMLSchema" xmlns:xs="http://www.w3.org/2001/XMLSchema" xmlns:p="http://schemas.microsoft.com/office/2006/metadata/properties" xmlns:ns2="25a369bd-ffdf-4711-8592-06418a0244de" targetNamespace="http://schemas.microsoft.com/office/2006/metadata/properties" ma:root="true" ma:fieldsID="0db20352f684ff61f3cbc15d9e6d1594" ns2:_="">
    <xsd:import namespace="25a369bd-ffdf-4711-8592-06418a0244d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5a369bd-ffdf-4711-8592-06418a0244d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44821F9D-F547-4577-A288-E24A2EADBFE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5a369bd-ffdf-4711-8592-06418a0244d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9E45E8F-CD10-4835-99E9-15FB333CDD6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8D875236-79F3-4337-8915-E83C08C33ABB}">
  <ds:schemaRefs>
    <ds:schemaRef ds:uri="http://schemas.microsoft.com/office/2006/metadata/properties"/>
    <ds:schemaRef ds:uri="http://schemas.microsoft.com/office/infopath/2007/PartnerControl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6056</TotalTime>
  <Words>129</Words>
  <Application>Microsoft Office PowerPoint</Application>
  <PresentationFormat>Widescreen</PresentationFormat>
  <Paragraphs>10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ech. Supplemental </dc:title>
  <dc:creator>Michael Maiden</dc:creator>
  <cp:lastModifiedBy>Waters, Christopher</cp:lastModifiedBy>
  <cp:revision>423</cp:revision>
  <dcterms:created xsi:type="dcterms:W3CDTF">2018-07-21T18:41:50Z</dcterms:created>
  <dcterms:modified xsi:type="dcterms:W3CDTF">2020-10-06T14:54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4DAA46E096FC440AE51667620FC2471</vt:lpwstr>
  </property>
</Properties>
</file>